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3" r:id="rId2"/>
    <p:sldId id="258" r:id="rId3"/>
    <p:sldId id="405"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2" d="100"/>
          <a:sy n="112" d="100"/>
        </p:scale>
        <p:origin x="552"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0D7B87-5E50-4A7E-BFD4-0192BCE4DDD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D110C2E7-F569-47BE-B164-0B6CD250692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4D1938C2-1CC1-4813-A89A-AD4617EEC003}"/>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072EA694-EF8C-47ED-B082-0E2D9C6CE12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1B3E710C-B56D-4515-B186-4869F7F54E1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5375046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4166DD-5803-481B-9EA1-803275FAF688}"/>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F97F62DB-7ECA-46BC-9CA9-C03D3B52C13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30E343FC-3B08-4B1A-AC05-7F3539D02D7F}"/>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C12C2D29-9C7F-4E66-AEF4-863C247F52E7}"/>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C858DE8-45B5-4EC2-900A-C58B0EEA088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26107221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7B7C317-D72D-4B8E-BC36-FB98BAC65B54}"/>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F34B46E8-C17F-444E-9D99-804B004C057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2A1FF991-E938-47CA-BE81-9B20F4B53BE1}"/>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FBC978A0-6A5A-4DBD-8529-15C1F301CD7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4E7FC61F-AD1C-4D3A-88B8-0BAED5DD5D1B}"/>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7664211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D021B9-95DD-4472-B951-E5951C60CED5}"/>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34AF5B67-4072-449D-ABDE-58C5AB803A0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8CCE8BFC-94B0-4512-B3BF-63F8A53754C6}"/>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A0EDC299-8F0A-480F-ABE3-BC0A05EFE1B3}"/>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6C1ABB65-33B9-4D80-A0F3-29D5C27FDB8E}"/>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36358228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D74B46-A3DD-461A-851F-6B470F53D73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83769EA0-3FDE-4D89-BB97-0D4219A6E3C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7664904-8791-43B4-A19B-1548A9BCD1E2}"/>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B7A2107C-8D48-4676-8C06-10C6AF588DE5}"/>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07F3450-CCE7-47E1-ADCA-106C1C9265F8}"/>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526726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241756-B78A-488E-89B5-03C5BFF0A94A}"/>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F417DADB-2CAF-4ED1-83D9-09C5960AB44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3FC8E895-C91E-4867-9303-9C1A3939DE3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CE3F8C7B-613A-488C-A42A-E25F4EA35161}"/>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6" name="Footer Placeholder 5">
            <a:extLst>
              <a:ext uri="{FF2B5EF4-FFF2-40B4-BE49-F238E27FC236}">
                <a16:creationId xmlns:a16="http://schemas.microsoft.com/office/drawing/2014/main" id="{C0B72DE2-457E-4533-BC3A-871D368B0FF3}"/>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54158D0A-8AA6-4A1E-81D3-17BAC945CC1D}"/>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807387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BE9455-E8A2-444A-9371-6BA7F87D672A}"/>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F50DDC17-B325-4D7E-83CE-243BAFBC5A3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8871795-B1E7-4176-B23E-47C7A29BDD8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EC39F2ED-FE4A-4E22-9D3E-1CB3D7932AF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C2F535-F17A-44BF-8871-BD674C1CCCB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C2805E75-970E-4B26-AE1E-DB6F38A00FE5}"/>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8" name="Footer Placeholder 7">
            <a:extLst>
              <a:ext uri="{FF2B5EF4-FFF2-40B4-BE49-F238E27FC236}">
                <a16:creationId xmlns:a16="http://schemas.microsoft.com/office/drawing/2014/main" id="{74B5B419-B01A-445D-ADBC-D0C6ABBC7D42}"/>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6BB4C254-F72D-4C88-A9AF-F13B4F5EEB22}"/>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7304656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125D3F-1F55-45F9-81C9-F635877D095A}"/>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BFACF315-E382-4739-B1B6-E8270DA776C5}"/>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4" name="Footer Placeholder 3">
            <a:extLst>
              <a:ext uri="{FF2B5EF4-FFF2-40B4-BE49-F238E27FC236}">
                <a16:creationId xmlns:a16="http://schemas.microsoft.com/office/drawing/2014/main" id="{FF55608B-802A-4893-AD47-73C5418BDF63}"/>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55FBA4D7-EDF9-4938-AA31-E781C03776D2}"/>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5627083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C151928-32B6-463D-9868-5618827FEBB4}"/>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3" name="Footer Placeholder 2">
            <a:extLst>
              <a:ext uri="{FF2B5EF4-FFF2-40B4-BE49-F238E27FC236}">
                <a16:creationId xmlns:a16="http://schemas.microsoft.com/office/drawing/2014/main" id="{56287473-26E0-4840-B0AE-B0D87D861AA0}"/>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C1FED30D-D265-4BB9-AA0B-2C8CB7A07C35}"/>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19941478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797FC7-813C-4276-A502-0D5C37AD89F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C1C28297-83C4-4381-8CDB-4ACDAC5DBF6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98A91EF5-FD30-4F2C-BB2B-FEE007C992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16A6DB1-977F-4F6C-85C1-7648BF8BE373}"/>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6" name="Footer Placeholder 5">
            <a:extLst>
              <a:ext uri="{FF2B5EF4-FFF2-40B4-BE49-F238E27FC236}">
                <a16:creationId xmlns:a16="http://schemas.microsoft.com/office/drawing/2014/main" id="{DB447C08-D1FB-458E-B1B3-55F99E7C5660}"/>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E77C343A-9010-40C5-A8C7-7551F51FE80A}"/>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27087509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48421-0AC1-4CC4-9DBD-550FDEBE7CE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B34A316A-691E-4605-B8BA-86E944175A6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60EED114-F516-4A69-BA11-C456571F7C6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84238F-96C3-41FE-BF17-81114A9B3BE8}"/>
              </a:ext>
            </a:extLst>
          </p:cNvPr>
          <p:cNvSpPr>
            <a:spLocks noGrp="1"/>
          </p:cNvSpPr>
          <p:nvPr>
            <p:ph type="dt" sz="half" idx="10"/>
          </p:nvPr>
        </p:nvSpPr>
        <p:spPr/>
        <p:txBody>
          <a:bodyPr/>
          <a:lstStyle/>
          <a:p>
            <a:fld id="{2FC8F268-B607-4E6B-9BFB-A5231F5250A2}" type="datetimeFigureOut">
              <a:rPr lang="en-IN" smtClean="0"/>
              <a:t>15-05-2022</a:t>
            </a:fld>
            <a:endParaRPr lang="en-IN"/>
          </a:p>
        </p:txBody>
      </p:sp>
      <p:sp>
        <p:nvSpPr>
          <p:cNvPr id="6" name="Footer Placeholder 5">
            <a:extLst>
              <a:ext uri="{FF2B5EF4-FFF2-40B4-BE49-F238E27FC236}">
                <a16:creationId xmlns:a16="http://schemas.microsoft.com/office/drawing/2014/main" id="{498F6ED2-FB01-48DC-B046-8502862C6307}"/>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29715235-702A-4B11-9489-ABD2E408933E}"/>
              </a:ext>
            </a:extLst>
          </p:cNvPr>
          <p:cNvSpPr>
            <a:spLocks noGrp="1"/>
          </p:cNvSpPr>
          <p:nvPr>
            <p:ph type="sldNum" sz="quarter" idx="12"/>
          </p:nvPr>
        </p:nvSpPr>
        <p:spPr/>
        <p:txBody>
          <a:bodyPr/>
          <a:lstStyle/>
          <a:p>
            <a:fld id="{5A62C79F-F10E-4232-A089-B81B6FB4FA74}" type="slidenum">
              <a:rPr lang="en-IN" smtClean="0"/>
              <a:t>‹#›</a:t>
            </a:fld>
            <a:endParaRPr lang="en-IN"/>
          </a:p>
        </p:txBody>
      </p:sp>
    </p:spTree>
    <p:extLst>
      <p:ext uri="{BB962C8B-B14F-4D97-AF65-F5344CB8AC3E}">
        <p14:creationId xmlns:p14="http://schemas.microsoft.com/office/powerpoint/2010/main" val="6647518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3AE1C97-B73A-4E49-ADD1-16C33EFE928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BF9A8050-D3F1-4E84-8D7C-C7D8DF60D6A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F75AEE39-B2AC-4A4D-B8DA-548D3E85D81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FC8F268-B607-4E6B-9BFB-A5231F5250A2}" type="datetimeFigureOut">
              <a:rPr lang="en-IN" smtClean="0"/>
              <a:t>15-05-2022</a:t>
            </a:fld>
            <a:endParaRPr lang="en-IN"/>
          </a:p>
        </p:txBody>
      </p:sp>
      <p:sp>
        <p:nvSpPr>
          <p:cNvPr id="5" name="Footer Placeholder 4">
            <a:extLst>
              <a:ext uri="{FF2B5EF4-FFF2-40B4-BE49-F238E27FC236}">
                <a16:creationId xmlns:a16="http://schemas.microsoft.com/office/drawing/2014/main" id="{10ED03FF-DB2E-4FCF-B446-D2A53F276BE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688E6A27-64DB-42E3-94F2-FD43AD25B23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2C79F-F10E-4232-A089-B81B6FB4FA74}" type="slidenum">
              <a:rPr lang="en-IN" smtClean="0"/>
              <a:t>‹#›</a:t>
            </a:fld>
            <a:endParaRPr lang="en-IN"/>
          </a:p>
        </p:txBody>
      </p:sp>
    </p:spTree>
    <p:extLst>
      <p:ext uri="{BB962C8B-B14F-4D97-AF65-F5344CB8AC3E}">
        <p14:creationId xmlns:p14="http://schemas.microsoft.com/office/powerpoint/2010/main" val="28677292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35B34F3-4FF0-4608-B603-4F0922A7A27A}"/>
              </a:ext>
            </a:extLst>
          </p:cNvPr>
          <p:cNvSpPr txBox="1"/>
          <p:nvPr/>
        </p:nvSpPr>
        <p:spPr>
          <a:xfrm>
            <a:off x="104827" y="5903893"/>
            <a:ext cx="11982345" cy="738664"/>
          </a:xfrm>
          <a:prstGeom prst="rect">
            <a:avLst/>
          </a:prstGeom>
          <a:noFill/>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a:t>
            </a: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1.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Work plan showing the Establishment of Primary HTM cell strains </a:t>
            </a:r>
            <a:r>
              <a:rPr lang="en-US" sz="1400" dirty="0">
                <a:latin typeface="Times New Roman" panose="02020603050405020304" pitchFamily="18" charset="0"/>
                <a:ea typeface="Calibri" panose="020F0502020204030204" pitchFamily="34" charset="0"/>
                <a:cs typeface="Times New Roman" panose="02020603050405020304" pitchFamily="18" charset="0"/>
              </a:rPr>
              <a:t>with Known GC Responsiveness.</a:t>
            </a:r>
          </a:p>
          <a:p>
            <a:r>
              <a:rPr lang="en-US" sz="1400" dirty="0">
                <a:latin typeface="Times New Roman" panose="02020603050405020304" pitchFamily="18" charset="0"/>
                <a:ea typeface="Calibri" panose="020F0502020204030204" pitchFamily="34" charset="0"/>
                <a:cs typeface="Times New Roman" panose="02020603050405020304" pitchFamily="18" charset="0"/>
              </a:rPr>
              <a:t>In this study, one eye of each pair was used to assess the GC responsiveness in HOCAS after 100nM DEX treatment and the other eye was used to establish the primary HTM cells. Based on the IOP response, the HTM cell strains  were categorized as GC-responder (GC-R) and non-responder (GC-NR) cells.</a:t>
            </a:r>
            <a:endParaRPr lang="en-IN" sz="1400"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D2B3199B-7D8B-477D-ADEF-97578C1EDC1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40645" y="0"/>
            <a:ext cx="6106191" cy="5882087"/>
          </a:xfrm>
          <a:prstGeom prst="rect">
            <a:avLst/>
          </a:prstGeom>
        </p:spPr>
      </p:pic>
    </p:spTree>
    <p:extLst>
      <p:ext uri="{BB962C8B-B14F-4D97-AF65-F5344CB8AC3E}">
        <p14:creationId xmlns:p14="http://schemas.microsoft.com/office/powerpoint/2010/main" val="2053834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381FA804-8101-44B4-9542-17CC994868B1}"/>
              </a:ext>
            </a:extLst>
          </p:cNvPr>
          <p:cNvSpPr/>
          <p:nvPr/>
        </p:nvSpPr>
        <p:spPr>
          <a:xfrm>
            <a:off x="0" y="5436715"/>
            <a:ext cx="12191999" cy="1384995"/>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a:t>
            </a: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a:t>
            </a:r>
            <a:r>
              <a:rPr lang="en-US" sz="1400" b="1" dirty="0">
                <a:latin typeface="Times New Roman" panose="02020603050405020304" pitchFamily="18" charset="0"/>
                <a:cs typeface="Times New Roman" panose="02020603050405020304" pitchFamily="18" charset="0"/>
              </a:rPr>
              <a:t>2. Isolation and Characterization of Primary HTM Cells. a</a:t>
            </a:r>
            <a:r>
              <a:rPr lang="en-US" sz="1400" dirty="0">
                <a:latin typeface="Times New Roman" panose="02020603050405020304" pitchFamily="18" charset="0"/>
                <a:cs typeface="Times New Roman" panose="02020603050405020304" pitchFamily="18" charset="0"/>
              </a:rPr>
              <a:t>) (</a:t>
            </a:r>
            <a:r>
              <a:rPr lang="en-US" sz="1400" dirty="0" err="1">
                <a:latin typeface="Times New Roman" panose="02020603050405020304" pitchFamily="18" charset="0"/>
                <a:cs typeface="Times New Roman" panose="02020603050405020304" pitchFamily="18" charset="0"/>
              </a:rPr>
              <a:t>i</a:t>
            </a:r>
            <a:r>
              <a:rPr lang="en-US" sz="1400" dirty="0">
                <a:latin typeface="Times New Roman" panose="02020603050405020304" pitchFamily="18" charset="0"/>
                <a:cs typeface="Times New Roman" panose="02020603050405020304" pitchFamily="18" charset="0"/>
              </a:rPr>
              <a:t>) Representative Phase-contrast image of HTM cells; Representative confocal</a:t>
            </a:r>
          </a:p>
          <a:p>
            <a:r>
              <a:rPr lang="en-US" sz="1400" dirty="0">
                <a:latin typeface="Times New Roman" panose="02020603050405020304" pitchFamily="18" charset="0"/>
                <a:cs typeface="Times New Roman" panose="02020603050405020304" pitchFamily="18" charset="0"/>
              </a:rPr>
              <a:t>images of HTM cells probed with (ii) aquaporin; (iii) myocilin; (iv) TRITC-Phalloidin after DEX treatment ; (v) CLANs under higher magnification (white arrow) and (vi) TRITC-Phalloidin after DEX treatment (CLAN negative). Blue: DAPI (Nucleus) ; Green: Myocilin; Red: Aquaporin &amp; TRITC Phalloidin. Graph showing the percentage of (</a:t>
            </a:r>
            <a:r>
              <a:rPr lang="en-US" sz="1400" b="1" dirty="0">
                <a:latin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cs typeface="Times New Roman" panose="02020603050405020304" pitchFamily="18" charset="0"/>
              </a:rPr>
              <a:t>) myocilin positive cells and (</a:t>
            </a:r>
            <a:r>
              <a:rPr lang="en-US" sz="1400" b="1" dirty="0">
                <a:latin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cs typeface="Times New Roman" panose="02020603050405020304" pitchFamily="18" charset="0"/>
              </a:rPr>
              <a:t>) CLAN positive cells in all GC-R and GC-NR groups studied after respective treatments in HTM cells. The data is represented as mean± SEM. **p &lt;0.005; ***p &lt;0.0005 ****p &lt;0.0001. Paired 2-tailed Student’s t test.</a:t>
            </a: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6264" y="212265"/>
            <a:ext cx="12192000" cy="4949725"/>
          </a:xfrm>
          <a:prstGeom prst="rect">
            <a:avLst/>
          </a:prstGeom>
        </p:spPr>
      </p:pic>
    </p:spTree>
    <p:extLst>
      <p:ext uri="{BB962C8B-B14F-4D97-AF65-F5344CB8AC3E}">
        <p14:creationId xmlns:p14="http://schemas.microsoft.com/office/powerpoint/2010/main" val="28297328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EB5C80E-3878-4C8F-8325-9C588AB2977B}"/>
              </a:ext>
            </a:extLst>
          </p:cNvPr>
          <p:cNvSpPr txBox="1"/>
          <p:nvPr/>
        </p:nvSpPr>
        <p:spPr>
          <a:xfrm>
            <a:off x="0" y="6046276"/>
            <a:ext cx="12095544" cy="523220"/>
          </a:xfrm>
          <a:prstGeom prst="rect">
            <a:avLst/>
          </a:prstGeom>
          <a:noFill/>
        </p:spPr>
        <p:txBody>
          <a:bodyPr wrap="square" rtlCol="0">
            <a:spAutoFit/>
          </a:bodyPr>
          <a:lstStyle/>
          <a:p>
            <a:r>
              <a:rPr lang="en-US" sz="1400" b="1">
                <a:latin typeface="Times New Roman" panose="02020603050405020304" pitchFamily="18" charset="0"/>
                <a:cs typeface="Times New Roman" panose="02020603050405020304" pitchFamily="18" charset="0"/>
              </a:rPr>
              <a:t>Supplementary </a:t>
            </a:r>
            <a:r>
              <a:rPr lang="en-US" sz="1400" b="1">
                <a:effectLst/>
                <a:latin typeface="Times New Roman" panose="02020603050405020304" pitchFamily="18" charset="0"/>
                <a:ea typeface="Calibri" panose="020F0502020204030204" pitchFamily="34" charset="0"/>
                <a:cs typeface="Times New Roman" panose="02020603050405020304" pitchFamily="18" charset="0"/>
              </a:rPr>
              <a:t>Figure S</a:t>
            </a:r>
            <a:r>
              <a:rPr lang="en-US" sz="1400" b="1">
                <a:latin typeface="Times New Roman" panose="02020603050405020304" pitchFamily="18" charset="0"/>
                <a:cs typeface="Times New Roman" panose="02020603050405020304" pitchFamily="18" charset="0"/>
              </a:rPr>
              <a:t>3</a:t>
            </a:r>
            <a:r>
              <a:rPr lang="en-US" sz="1400" b="1" dirty="0">
                <a:latin typeface="Times New Roman" panose="02020603050405020304" pitchFamily="18" charset="0"/>
                <a:cs typeface="Times New Roman" panose="02020603050405020304" pitchFamily="18" charset="0"/>
              </a:rPr>
              <a:t>. </a:t>
            </a:r>
            <a:r>
              <a:rPr lang="en-US" sz="1400" dirty="0">
                <a:latin typeface="Times New Roman" panose="02020603050405020304" pitchFamily="18" charset="0"/>
                <a:cs typeface="Times New Roman" panose="02020603050405020304" pitchFamily="18" charset="0"/>
              </a:rPr>
              <a:t>Principle Component Analysis (PCA) of RNA Seq data from Normalized Read Counts in Comparison of DEX to ETH (Vehicle). GC-R:DEX-treated; ETH-treated HTM cells, n=4; GC-NR: DEX-treated; ETH- treated HTM cells, n=4</a:t>
            </a:r>
          </a:p>
        </p:txBody>
      </p:sp>
      <p:pic>
        <p:nvPicPr>
          <p:cNvPr id="12" name="Picture 11">
            <a:extLst>
              <a:ext uri="{FF2B5EF4-FFF2-40B4-BE49-F238E27FC236}">
                <a16:creationId xmlns:a16="http://schemas.microsoft.com/office/drawing/2014/main" id="{25C8CBE0-E313-4738-99D4-67CA3384E00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90772" y="716819"/>
            <a:ext cx="6809008" cy="4804305"/>
          </a:xfrm>
          <a:prstGeom prst="rect">
            <a:avLst/>
          </a:prstGeom>
        </p:spPr>
      </p:pic>
    </p:spTree>
    <p:extLst>
      <p:ext uri="{BB962C8B-B14F-4D97-AF65-F5344CB8AC3E}">
        <p14:creationId xmlns:p14="http://schemas.microsoft.com/office/powerpoint/2010/main" val="31880778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79</TotalTime>
  <Words>281</Words>
  <Application>Microsoft Office PowerPoint</Application>
  <PresentationFormat>Widescreen</PresentationFormat>
  <Paragraphs>5</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Times New Roman</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ribalaganesh Ravinarayanan</dc:creator>
  <cp:lastModifiedBy>MDPI</cp:lastModifiedBy>
  <cp:revision>62</cp:revision>
  <cp:lastPrinted>2020-12-31T06:41:13Z</cp:lastPrinted>
  <dcterms:created xsi:type="dcterms:W3CDTF">2020-10-12T10:22:11Z</dcterms:created>
  <dcterms:modified xsi:type="dcterms:W3CDTF">2022-05-15T07:50:50Z</dcterms:modified>
</cp:coreProperties>
</file>